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32"/>
    <p:restoredTop sz="94651"/>
  </p:normalViewPr>
  <p:slideViewPr>
    <p:cSldViewPr snapToGrid="0" snapToObjects="1">
      <p:cViewPr varScale="1">
        <p:scale>
          <a:sx n="117" d="100"/>
          <a:sy n="117" d="100"/>
        </p:scale>
        <p:origin x="139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469382-5368-6B4D-8401-08C4EF61FFD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85602D9-B486-7E46-A7BB-298E077D96B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F14F30-56F1-2146-8317-B50AA0EB8D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5DBF7-298C-534B-9CAD-FB7B2BAC02F4}" type="datetimeFigureOut">
              <a:rPr lang="en-US" smtClean="0"/>
              <a:t>11/2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DB2AD2-E804-E940-AF7D-0BF5091434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7F2CB9-3D7D-0A44-B524-26C27F77FB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44FEB-BB46-184A-B48C-E335814231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884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94B18C-7E82-484D-BC2D-1764302562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CBF726F-D54B-BC41-BE72-8EFE4334E9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069D50-CE3A-C34D-A1BB-3B4F0F9100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5DBF7-298C-534B-9CAD-FB7B2BAC02F4}" type="datetimeFigureOut">
              <a:rPr lang="en-US" smtClean="0"/>
              <a:t>11/2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50208C-545C-574E-89F8-D2DE3CEC96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683226-F0EB-E94D-82EB-F4554EB143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44FEB-BB46-184A-B48C-E335814231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80293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F0BC11A-60DB-9F44-9391-7C15ECCEBD7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B3F9B4E-2BDD-1242-BCA0-88123075B6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56B936-5302-D441-BD6C-AA425D4C9B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5DBF7-298C-534B-9CAD-FB7B2BAC02F4}" type="datetimeFigureOut">
              <a:rPr lang="en-US" smtClean="0"/>
              <a:t>11/2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DE6A7B-37DD-1343-B7A1-B84E957ACA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DB9CB1-E9CE-6A4A-BEDF-18A839194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44FEB-BB46-184A-B48C-E335814231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530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42ECFB-315E-AD43-98ED-AA9D818FEB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E75EAA-8B4E-344E-BE2B-03EEB9641E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F72270-F293-1D41-B454-D530ED1E59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5DBF7-298C-534B-9CAD-FB7B2BAC02F4}" type="datetimeFigureOut">
              <a:rPr lang="en-US" smtClean="0"/>
              <a:t>11/2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E7D80C-F9AB-CF40-B41B-552D1A2F3C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C4DEC5-374D-214D-A3FA-8EC8C2A8F5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44FEB-BB46-184A-B48C-E335814231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40627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8A7570-B278-344F-9CA2-B209DAC182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FBC51D-535B-8442-8DF9-D07948BAE4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22F8ED-F38E-924B-86B4-4B08536E95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5DBF7-298C-534B-9CAD-FB7B2BAC02F4}" type="datetimeFigureOut">
              <a:rPr lang="en-US" smtClean="0"/>
              <a:t>11/2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22C33A-3D9A-A948-85E4-B2F11443D9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68E896-D5A2-F744-AAEC-9308206BB3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44FEB-BB46-184A-B48C-E335814231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10245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7C33BC-531B-674E-850E-04E1439633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CB68D6-2A33-F042-9242-457440F203F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B78D77-58E2-594F-972C-DC3EC07D6C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5BB799-A9EB-3F4F-8F8E-BCA42FE6A8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5DBF7-298C-534B-9CAD-FB7B2BAC02F4}" type="datetimeFigureOut">
              <a:rPr lang="en-US" smtClean="0"/>
              <a:t>11/2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8957C5-FC15-2441-BF22-6F7D10D984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50C908-17D9-2B4F-995F-940320A5C9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44FEB-BB46-184A-B48C-E335814231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0036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D856ED-FE12-914D-AE0B-3AE28397B7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9E5DEC-64DE-E244-9E26-C12505FC51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EE76882-1480-A148-AA2B-1B272156B4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A12D02B-8FEF-E147-B3CE-26CE419383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7F172C4-F831-E444-BBC8-1BEB9AA4F1B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BF6D6AC-5511-0942-BBE9-D00900EA4B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5DBF7-298C-534B-9CAD-FB7B2BAC02F4}" type="datetimeFigureOut">
              <a:rPr lang="en-US" smtClean="0"/>
              <a:t>11/25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33868F1-627A-DB46-8BEC-11036A0A03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C3FD14E-857C-EE4D-A1C2-BC65594EA9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44FEB-BB46-184A-B48C-E335814231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03684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765ED9-519B-D541-B020-D6BB493924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1A40FBE-31D0-614C-A3C8-D4A3C2DAC2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5DBF7-298C-534B-9CAD-FB7B2BAC02F4}" type="datetimeFigureOut">
              <a:rPr lang="en-US" smtClean="0"/>
              <a:t>11/25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F385F63-B225-EF45-9B9C-C2FCF98C1F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2DED632-80A6-BC4F-9DCE-F5FD36F4BA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44FEB-BB46-184A-B48C-E335814231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31723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54545BD-462A-1142-BA94-F74A5C9E1A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5DBF7-298C-534B-9CAD-FB7B2BAC02F4}" type="datetimeFigureOut">
              <a:rPr lang="en-US" smtClean="0"/>
              <a:t>11/25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9F6ADAF-7B10-9144-823D-6C9DD8A736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FF7721B-EC84-F042-ABB0-36BDD30FC1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44FEB-BB46-184A-B48C-E335814231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1669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0136EF-B4D8-7E4F-B747-712824AAA6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C14340-1119-904C-B740-7CBDEEA1DE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1F950A1-EE3E-6049-B72B-91E39CDA58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28CC0A-2F9A-4B46-9934-B017FAB1FF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5DBF7-298C-534B-9CAD-FB7B2BAC02F4}" type="datetimeFigureOut">
              <a:rPr lang="en-US" smtClean="0"/>
              <a:t>11/2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0FF941-2A51-C747-A15C-AE202A1A6D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56D0B9-E074-0C42-9C1A-FD7A57E7B2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44FEB-BB46-184A-B48C-E335814231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0371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4F6A5E-C7AE-C047-891C-DAFA6D59C2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012D63F-E11F-4047-94FA-839931D893F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083E257-6179-B244-8500-B71422568A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025212-28FD-E14A-A43F-3C504DF702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5DBF7-298C-534B-9CAD-FB7B2BAC02F4}" type="datetimeFigureOut">
              <a:rPr lang="en-US" smtClean="0"/>
              <a:t>11/2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2EEF29-F183-8A49-97A7-9052516A7B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B9CC37-582E-3042-A0EC-57FA7B93E3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844FEB-BB46-184A-B48C-E335814231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89287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DBCF855-F90D-B64F-828E-9DA30E83D8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7D0CF7-8D74-364F-A085-6926EB5809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422339-86C9-DD42-AA72-ACCFE3C3052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65DBF7-298C-534B-9CAD-FB7B2BAC02F4}" type="datetimeFigureOut">
              <a:rPr lang="en-US" smtClean="0"/>
              <a:t>11/2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0ADE38-EF92-394F-A35D-BF868C5736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F60998-5830-2E45-B42D-29E62DB22C7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44FEB-BB46-184A-B48C-E335814231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5250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BCC8823-3F82-DF40-9B90-AABEE5BFD187}"/>
              </a:ext>
            </a:extLst>
          </p:cNvPr>
          <p:cNvSpPr txBox="1"/>
          <p:nvPr/>
        </p:nvSpPr>
        <p:spPr>
          <a:xfrm>
            <a:off x="1066800" y="598714"/>
            <a:ext cx="207364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Pearson, et al</a:t>
            </a:r>
          </a:p>
          <a:p>
            <a:r>
              <a:rPr lang="en-US" dirty="0"/>
              <a:t>Figure 2A/B</a:t>
            </a:r>
          </a:p>
          <a:p>
            <a:r>
              <a:rPr lang="en-US" dirty="0"/>
              <a:t>Original gel photos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49203D3-959E-5C46-9532-14D5D59B622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lum bright="1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5" t="4427" b="77866"/>
          <a:stretch>
            <a:fillRect/>
          </a:stretch>
        </p:blipFill>
        <p:spPr bwMode="auto">
          <a:xfrm>
            <a:off x="2877458" y="1676400"/>
            <a:ext cx="6480175" cy="182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825DCBB-B0CB-9841-A8CF-8C659C4600B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92" b="78291"/>
          <a:stretch>
            <a:fillRect/>
          </a:stretch>
        </p:blipFill>
        <p:spPr bwMode="auto">
          <a:xfrm>
            <a:off x="2877458" y="3820885"/>
            <a:ext cx="6575425" cy="1752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D9C990D-08A6-6747-A426-37C331C27A2A}"/>
              </a:ext>
            </a:extLst>
          </p:cNvPr>
          <p:cNvSpPr txBox="1"/>
          <p:nvPr/>
        </p:nvSpPr>
        <p:spPr>
          <a:xfrm>
            <a:off x="2405742" y="167640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574AF45-B36D-BD4A-B5B4-B2B3D92993A5}"/>
              </a:ext>
            </a:extLst>
          </p:cNvPr>
          <p:cNvSpPr txBox="1"/>
          <p:nvPr/>
        </p:nvSpPr>
        <p:spPr>
          <a:xfrm>
            <a:off x="2405742" y="3820885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424040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BCC8823-3F82-DF40-9B90-AABEE5BFD187}"/>
              </a:ext>
            </a:extLst>
          </p:cNvPr>
          <p:cNvSpPr txBox="1"/>
          <p:nvPr/>
        </p:nvSpPr>
        <p:spPr>
          <a:xfrm>
            <a:off x="1066800" y="598714"/>
            <a:ext cx="985507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Pearson, et al</a:t>
            </a:r>
          </a:p>
          <a:p>
            <a:r>
              <a:rPr lang="en-US" dirty="0"/>
              <a:t>Figure 6</a:t>
            </a:r>
          </a:p>
          <a:p>
            <a:r>
              <a:rPr lang="en-US" dirty="0"/>
              <a:t>Original gel photo:  this image is the totality of what was captured; there was no cropping for the figure</a:t>
            </a:r>
          </a:p>
          <a:p>
            <a:r>
              <a:rPr lang="en-US" dirty="0"/>
              <a:t>included in the manuscript </a:t>
            </a:r>
          </a:p>
        </p:txBody>
      </p:sp>
      <p:pic>
        <p:nvPicPr>
          <p:cNvPr id="8" name="Picture 1">
            <a:extLst>
              <a:ext uri="{FF2B5EF4-FFF2-40B4-BE49-F238E27FC236}">
                <a16:creationId xmlns:a16="http://schemas.microsoft.com/office/drawing/2014/main" id="{35BB8AF7-6A84-8349-B83C-DB13C66976D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056" t="23891" r="1" b="19228"/>
          <a:stretch/>
        </p:blipFill>
        <p:spPr bwMode="auto">
          <a:xfrm>
            <a:off x="5571466" y="2579914"/>
            <a:ext cx="2502559" cy="24275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6768681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BCC8823-3F82-DF40-9B90-AABEE5BFD187}"/>
              </a:ext>
            </a:extLst>
          </p:cNvPr>
          <p:cNvSpPr txBox="1"/>
          <p:nvPr/>
        </p:nvSpPr>
        <p:spPr>
          <a:xfrm>
            <a:off x="1066800" y="598714"/>
            <a:ext cx="10283136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Pearson, et al</a:t>
            </a:r>
          </a:p>
          <a:p>
            <a:r>
              <a:rPr lang="en-US" dirty="0"/>
              <a:t>Figure 7</a:t>
            </a:r>
          </a:p>
          <a:p>
            <a:r>
              <a:rPr lang="en-US" dirty="0"/>
              <a:t>Original gel photo:  the two lanes in the figure are the totality of what was captured; there was no cropping </a:t>
            </a:r>
          </a:p>
          <a:p>
            <a:r>
              <a:rPr lang="en-US" dirty="0"/>
              <a:t>for the figure included in the manuscript </a:t>
            </a:r>
          </a:p>
        </p:txBody>
      </p:sp>
      <p:pic>
        <p:nvPicPr>
          <p:cNvPr id="5" name="Picture 27">
            <a:extLst>
              <a:ext uri="{FF2B5EF4-FFF2-40B4-BE49-F238E27FC236}">
                <a16:creationId xmlns:a16="http://schemas.microsoft.com/office/drawing/2014/main" id="{442A3EFE-C961-D34B-8F52-314080753BA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46171" y="1709747"/>
            <a:ext cx="3079750" cy="49164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2939706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BCC8823-3F82-DF40-9B90-AABEE5BFD187}"/>
              </a:ext>
            </a:extLst>
          </p:cNvPr>
          <p:cNvSpPr txBox="1"/>
          <p:nvPr/>
        </p:nvSpPr>
        <p:spPr>
          <a:xfrm>
            <a:off x="1066800" y="598714"/>
            <a:ext cx="1860446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Pearson, et al</a:t>
            </a:r>
          </a:p>
          <a:p>
            <a:r>
              <a:rPr lang="en-US" dirty="0"/>
              <a:t>Figure 8</a:t>
            </a:r>
          </a:p>
          <a:p>
            <a:r>
              <a:rPr lang="en-US" dirty="0"/>
              <a:t>Original gel photo</a:t>
            </a:r>
          </a:p>
        </p:txBody>
      </p:sp>
      <p:pic>
        <p:nvPicPr>
          <p:cNvPr id="6" name="Picture 2">
            <a:extLst>
              <a:ext uri="{FF2B5EF4-FFF2-40B4-BE49-F238E27FC236}">
                <a16:creationId xmlns:a16="http://schemas.microsoft.com/office/drawing/2014/main" id="{12F946CC-317F-6B4F-A786-96ED6DBE5C5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598"/>
          <a:stretch>
            <a:fillRect/>
          </a:stretch>
        </p:blipFill>
        <p:spPr bwMode="auto">
          <a:xfrm>
            <a:off x="1977749" y="2307772"/>
            <a:ext cx="8232144" cy="39070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3507814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88</Words>
  <Application>Microsoft Macintosh PowerPoint</Application>
  <PresentationFormat>Widescreen</PresentationFormat>
  <Paragraphs>1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ll, Glenn</dc:creator>
  <cp:lastModifiedBy>Rall, Glenn</cp:lastModifiedBy>
  <cp:revision>2</cp:revision>
  <dcterms:created xsi:type="dcterms:W3CDTF">2020-11-25T17:46:36Z</dcterms:created>
  <dcterms:modified xsi:type="dcterms:W3CDTF">2020-11-25T17:57:02Z</dcterms:modified>
</cp:coreProperties>
</file>